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80" r:id="rId5"/>
    <p:sldId id="277" r:id="rId6"/>
    <p:sldId id="276" r:id="rId7"/>
    <p:sldId id="278" r:id="rId8"/>
    <p:sldId id="264" r:id="rId9"/>
    <p:sldId id="269" r:id="rId10"/>
    <p:sldId id="271" r:id="rId11"/>
    <p:sldId id="272" r:id="rId12"/>
    <p:sldId id="274" r:id="rId13"/>
    <p:sldId id="273" r:id="rId14"/>
    <p:sldId id="279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ares, Miriam [mhares]" initials="HM[" lastIdx="2" clrIdx="0">
    <p:extLst>
      <p:ext uri="{19B8F6BF-5375-455C-9EA6-DF929625EA0E}">
        <p15:presenceInfo xmlns:p15="http://schemas.microsoft.com/office/powerpoint/2012/main" userId="S-1-5-21-137024685-2204166116-4157399963-45236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0033"/>
    <a:srgbClr val="FF8989"/>
    <a:srgbClr val="CC99FF"/>
    <a:srgbClr val="FFD966"/>
    <a:srgbClr val="E6E6E6"/>
    <a:srgbClr val="2BFF2B"/>
    <a:srgbClr val="4EFF4E"/>
    <a:srgbClr val="FF5959"/>
    <a:srgbClr val="5AFF5A"/>
    <a:srgbClr val="5CFF5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7" d="100"/>
          <a:sy n="57" d="100"/>
        </p:scale>
        <p:origin x="190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microsoft.com/office/2016/11/relationships/changesInfo" Target="changesInfos/changesInfo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res, Miriam [mhares]" userId="166e42af-e391-4b3a-8429-d0d3ab1076af" providerId="ADAL" clId="{A237EA95-C6D9-44C1-97A9-607DEE4F16F2}"/>
    <pc:docChg chg="undo custSel addSld modSld sldOrd">
      <pc:chgData name="Hares, Miriam [mhares]" userId="166e42af-e391-4b3a-8429-d0d3ab1076af" providerId="ADAL" clId="{A237EA95-C6D9-44C1-97A9-607DEE4F16F2}" dt="2023-09-07T16:44:27.018" v="577" actId="20577"/>
      <pc:docMkLst>
        <pc:docMk/>
      </pc:docMkLst>
      <pc:sldChg chg="addSp delSp modSp">
        <pc:chgData name="Hares, Miriam [mhares]" userId="166e42af-e391-4b3a-8429-d0d3ab1076af" providerId="ADAL" clId="{A237EA95-C6D9-44C1-97A9-607DEE4F16F2}" dt="2023-09-06T11:55:23.262" v="78" actId="20577"/>
        <pc:sldMkLst>
          <pc:docMk/>
          <pc:sldMk cId="2023538328" sldId="264"/>
        </pc:sldMkLst>
        <pc:spChg chg="mod">
          <ac:chgData name="Hares, Miriam [mhares]" userId="166e42af-e391-4b3a-8429-d0d3ab1076af" providerId="ADAL" clId="{A237EA95-C6D9-44C1-97A9-607DEE4F16F2}" dt="2023-09-06T11:55:23.262" v="78" actId="20577"/>
          <ac:spMkLst>
            <pc:docMk/>
            <pc:sldMk cId="2023538328" sldId="264"/>
            <ac:spMk id="10" creationId="{3C872F46-72BE-4CC3-BED4-CB279D6F508B}"/>
          </ac:spMkLst>
        </pc:spChg>
        <pc:picChg chg="del">
          <ac:chgData name="Hares, Miriam [mhares]" userId="166e42af-e391-4b3a-8429-d0d3ab1076af" providerId="ADAL" clId="{A237EA95-C6D9-44C1-97A9-607DEE4F16F2}" dt="2023-09-04T12:32:50.295" v="39" actId="478"/>
          <ac:picMkLst>
            <pc:docMk/>
            <pc:sldMk cId="2023538328" sldId="264"/>
            <ac:picMk id="3" creationId="{3D51968F-2EB0-4796-8FD7-DF9CCEB475E9}"/>
          </ac:picMkLst>
        </pc:picChg>
        <pc:picChg chg="add mod">
          <ac:chgData name="Hares, Miriam [mhares]" userId="166e42af-e391-4b3a-8429-d0d3ab1076af" providerId="ADAL" clId="{A237EA95-C6D9-44C1-97A9-607DEE4F16F2}" dt="2023-09-04T12:33:11.610" v="43" actId="1076"/>
          <ac:picMkLst>
            <pc:docMk/>
            <pc:sldMk cId="2023538328" sldId="264"/>
            <ac:picMk id="4" creationId="{CC1839D3-D3D5-460A-B3F9-1EDE38D83C50}"/>
          </ac:picMkLst>
        </pc:picChg>
      </pc:sldChg>
      <pc:sldChg chg="modSp">
        <pc:chgData name="Hares, Miriam [mhares]" userId="166e42af-e391-4b3a-8429-d0d3ab1076af" providerId="ADAL" clId="{A237EA95-C6D9-44C1-97A9-607DEE4F16F2}" dt="2023-09-07T16:44:27.018" v="577" actId="20577"/>
        <pc:sldMkLst>
          <pc:docMk/>
          <pc:sldMk cId="4096578201" sldId="269"/>
        </pc:sldMkLst>
        <pc:spChg chg="mod">
          <ac:chgData name="Hares, Miriam [mhares]" userId="166e42af-e391-4b3a-8429-d0d3ab1076af" providerId="ADAL" clId="{A237EA95-C6D9-44C1-97A9-607DEE4F16F2}" dt="2023-09-07T16:44:27.018" v="577" actId="20577"/>
          <ac:spMkLst>
            <pc:docMk/>
            <pc:sldMk cId="4096578201" sldId="269"/>
            <ac:spMk id="6" creationId="{82D7A7B8-48C5-446F-B4D2-DEBAAF0F1B15}"/>
          </ac:spMkLst>
        </pc:spChg>
      </pc:sldChg>
      <pc:sldChg chg="modSp">
        <pc:chgData name="Hares, Miriam [mhares]" userId="166e42af-e391-4b3a-8429-d0d3ab1076af" providerId="ADAL" clId="{A237EA95-C6D9-44C1-97A9-607DEE4F16F2}" dt="2023-09-06T11:59:42.923" v="150" actId="114"/>
        <pc:sldMkLst>
          <pc:docMk/>
          <pc:sldMk cId="2296738623" sldId="271"/>
        </pc:sldMkLst>
        <pc:spChg chg="mod">
          <ac:chgData name="Hares, Miriam [mhares]" userId="166e42af-e391-4b3a-8429-d0d3ab1076af" providerId="ADAL" clId="{A237EA95-C6D9-44C1-97A9-607DEE4F16F2}" dt="2023-09-06T11:59:42.923" v="150" actId="114"/>
          <ac:spMkLst>
            <pc:docMk/>
            <pc:sldMk cId="2296738623" sldId="271"/>
            <ac:spMk id="3" creationId="{193F1E42-4417-492A-85E2-69E79DBD2BF8}"/>
          </ac:spMkLst>
        </pc:spChg>
      </pc:sldChg>
      <pc:sldChg chg="modSp">
        <pc:chgData name="Hares, Miriam [mhares]" userId="166e42af-e391-4b3a-8429-d0d3ab1076af" providerId="ADAL" clId="{A237EA95-C6D9-44C1-97A9-607DEE4F16F2}" dt="2023-09-06T12:00:25.247" v="154" actId="20577"/>
        <pc:sldMkLst>
          <pc:docMk/>
          <pc:sldMk cId="3701283263" sldId="272"/>
        </pc:sldMkLst>
        <pc:spChg chg="mod">
          <ac:chgData name="Hares, Miriam [mhares]" userId="166e42af-e391-4b3a-8429-d0d3ab1076af" providerId="ADAL" clId="{A237EA95-C6D9-44C1-97A9-607DEE4F16F2}" dt="2023-09-06T12:00:25.247" v="154" actId="20577"/>
          <ac:spMkLst>
            <pc:docMk/>
            <pc:sldMk cId="3701283263" sldId="272"/>
            <ac:spMk id="3" creationId="{F1F6AF35-9227-487B-965D-D36D983B2A4B}"/>
          </ac:spMkLst>
        </pc:spChg>
      </pc:sldChg>
      <pc:sldChg chg="addSp delSp modSp">
        <pc:chgData name="Hares, Miriam [mhares]" userId="166e42af-e391-4b3a-8429-d0d3ab1076af" providerId="ADAL" clId="{A237EA95-C6D9-44C1-97A9-607DEE4F16F2}" dt="2023-09-06T15:17:42.084" v="219" actId="1076"/>
        <pc:sldMkLst>
          <pc:docMk/>
          <pc:sldMk cId="138810184" sldId="273"/>
        </pc:sldMkLst>
        <pc:spChg chg="mod">
          <ac:chgData name="Hares, Miriam [mhares]" userId="166e42af-e391-4b3a-8429-d0d3ab1076af" providerId="ADAL" clId="{A237EA95-C6D9-44C1-97A9-607DEE4F16F2}" dt="2023-09-06T15:14:54.748" v="215" actId="20577"/>
          <ac:spMkLst>
            <pc:docMk/>
            <pc:sldMk cId="138810184" sldId="273"/>
            <ac:spMk id="35" creationId="{A2AAD6C5-35CF-48CC-BE0B-5EFCEFB0B9D3}"/>
          </ac:spMkLst>
        </pc:spChg>
        <pc:picChg chg="add mod">
          <ac:chgData name="Hares, Miriam [mhares]" userId="166e42af-e391-4b3a-8429-d0d3ab1076af" providerId="ADAL" clId="{A237EA95-C6D9-44C1-97A9-607DEE4F16F2}" dt="2023-09-06T15:17:42.084" v="219" actId="1076"/>
          <ac:picMkLst>
            <pc:docMk/>
            <pc:sldMk cId="138810184" sldId="273"/>
            <ac:picMk id="3" creationId="{862378CD-6A79-47CD-9A20-D38A08AA110C}"/>
          </ac:picMkLst>
        </pc:picChg>
        <pc:picChg chg="del">
          <ac:chgData name="Hares, Miriam [mhares]" userId="166e42af-e391-4b3a-8429-d0d3ab1076af" providerId="ADAL" clId="{A237EA95-C6D9-44C1-97A9-607DEE4F16F2}" dt="2023-09-06T15:17:37.234" v="218" actId="478"/>
          <ac:picMkLst>
            <pc:docMk/>
            <pc:sldMk cId="138810184" sldId="273"/>
            <ac:picMk id="48" creationId="{08193C04-6DCF-44A0-970E-BB63BC0BD5DF}"/>
          </ac:picMkLst>
        </pc:picChg>
      </pc:sldChg>
      <pc:sldChg chg="modSp">
        <pc:chgData name="Hares, Miriam [mhares]" userId="166e42af-e391-4b3a-8429-d0d3ab1076af" providerId="ADAL" clId="{A237EA95-C6D9-44C1-97A9-607DEE4F16F2}" dt="2023-09-06T12:00:31.556" v="157" actId="113"/>
        <pc:sldMkLst>
          <pc:docMk/>
          <pc:sldMk cId="2579154921" sldId="274"/>
        </pc:sldMkLst>
        <pc:spChg chg="mod">
          <ac:chgData name="Hares, Miriam [mhares]" userId="166e42af-e391-4b3a-8429-d0d3ab1076af" providerId="ADAL" clId="{A237EA95-C6D9-44C1-97A9-607DEE4F16F2}" dt="2023-09-06T12:00:31.556" v="157" actId="113"/>
          <ac:spMkLst>
            <pc:docMk/>
            <pc:sldMk cId="2579154921" sldId="274"/>
            <ac:spMk id="27" creationId="{2EB9BAC0-AD9C-4737-BE6A-A67FEA2DA460}"/>
          </ac:spMkLst>
        </pc:spChg>
      </pc:sldChg>
      <pc:sldChg chg="modSp">
        <pc:chgData name="Hares, Miriam [mhares]" userId="166e42af-e391-4b3a-8429-d0d3ab1076af" providerId="ADAL" clId="{A237EA95-C6D9-44C1-97A9-607DEE4F16F2}" dt="2023-09-06T10:25:45.993" v="69" actId="123"/>
        <pc:sldMkLst>
          <pc:docMk/>
          <pc:sldMk cId="1852045471" sldId="276"/>
        </pc:sldMkLst>
        <pc:spChg chg="mod">
          <ac:chgData name="Hares, Miriam [mhares]" userId="166e42af-e391-4b3a-8429-d0d3ab1076af" providerId="ADAL" clId="{A237EA95-C6D9-44C1-97A9-607DEE4F16F2}" dt="2023-09-06T10:25:45.993" v="69" actId="123"/>
          <ac:spMkLst>
            <pc:docMk/>
            <pc:sldMk cId="1852045471" sldId="276"/>
            <ac:spMk id="14" creationId="{AC4B85E7-70FF-4A20-B692-777613C2B159}"/>
          </ac:spMkLst>
        </pc:spChg>
      </pc:sldChg>
      <pc:sldChg chg="modSp">
        <pc:chgData name="Hares, Miriam [mhares]" userId="166e42af-e391-4b3a-8429-d0d3ab1076af" providerId="ADAL" clId="{A237EA95-C6D9-44C1-97A9-607DEE4F16F2}" dt="2023-09-06T10:24:30.474" v="58" actId="113"/>
        <pc:sldMkLst>
          <pc:docMk/>
          <pc:sldMk cId="3210815213" sldId="277"/>
        </pc:sldMkLst>
        <pc:spChg chg="mod">
          <ac:chgData name="Hares, Miriam [mhares]" userId="166e42af-e391-4b3a-8429-d0d3ab1076af" providerId="ADAL" clId="{A237EA95-C6D9-44C1-97A9-607DEE4F16F2}" dt="2023-09-06T10:24:30.474" v="58" actId="113"/>
          <ac:spMkLst>
            <pc:docMk/>
            <pc:sldMk cId="3210815213" sldId="277"/>
            <ac:spMk id="12" creationId="{9986C42B-BDEF-45F3-BAFE-37A0408BFDCC}"/>
          </ac:spMkLst>
        </pc:spChg>
      </pc:sldChg>
      <pc:sldChg chg="modSp">
        <pc:chgData name="Hares, Miriam [mhares]" userId="166e42af-e391-4b3a-8429-d0d3ab1076af" providerId="ADAL" clId="{A237EA95-C6D9-44C1-97A9-607DEE4F16F2}" dt="2023-09-07T15:17:23.335" v="555" actId="20577"/>
        <pc:sldMkLst>
          <pc:docMk/>
          <pc:sldMk cId="4187525010" sldId="278"/>
        </pc:sldMkLst>
        <pc:spChg chg="mod">
          <ac:chgData name="Hares, Miriam [mhares]" userId="166e42af-e391-4b3a-8429-d0d3ab1076af" providerId="ADAL" clId="{A237EA95-C6D9-44C1-97A9-607DEE4F16F2}" dt="2023-09-07T15:17:23.335" v="555" actId="20577"/>
          <ac:spMkLst>
            <pc:docMk/>
            <pc:sldMk cId="4187525010" sldId="278"/>
            <ac:spMk id="11" creationId="{64CC8A49-5B8F-4564-AEDD-D8384F0CA666}"/>
          </ac:spMkLst>
        </pc:spChg>
      </pc:sldChg>
      <pc:sldChg chg="modSp ord">
        <pc:chgData name="Hares, Miriam [mhares]" userId="166e42af-e391-4b3a-8429-d0d3ab1076af" providerId="ADAL" clId="{A237EA95-C6D9-44C1-97A9-607DEE4F16F2}" dt="2023-09-07T13:08:29.310" v="278" actId="20577"/>
        <pc:sldMkLst>
          <pc:docMk/>
          <pc:sldMk cId="1705917152" sldId="279"/>
        </pc:sldMkLst>
        <pc:spChg chg="mod">
          <ac:chgData name="Hares, Miriam [mhares]" userId="166e42af-e391-4b3a-8429-d0d3ab1076af" providerId="ADAL" clId="{A237EA95-C6D9-44C1-97A9-607DEE4F16F2}" dt="2023-09-06T12:01:18.831" v="166" actId="20577"/>
          <ac:spMkLst>
            <pc:docMk/>
            <pc:sldMk cId="1705917152" sldId="279"/>
            <ac:spMk id="5" creationId="{CD190061-81A3-4091-BA7D-A8270420DD28}"/>
          </ac:spMkLst>
        </pc:spChg>
        <pc:graphicFrameChg chg="modGraphic">
          <ac:chgData name="Hares, Miriam [mhares]" userId="166e42af-e391-4b3a-8429-d0d3ab1076af" providerId="ADAL" clId="{A237EA95-C6D9-44C1-97A9-607DEE4F16F2}" dt="2023-09-07T13:08:29.310" v="278" actId="20577"/>
          <ac:graphicFrameMkLst>
            <pc:docMk/>
            <pc:sldMk cId="1705917152" sldId="279"/>
            <ac:graphicFrameMk id="4" creationId="{535F7B94-BC90-4559-9BE3-81F9AE49E0E4}"/>
          </ac:graphicFrameMkLst>
        </pc:graphicFrameChg>
      </pc:sldChg>
      <pc:sldChg chg="addSp delSp modSp add">
        <pc:chgData name="Hares, Miriam [mhares]" userId="166e42af-e391-4b3a-8429-d0d3ab1076af" providerId="ADAL" clId="{A237EA95-C6D9-44C1-97A9-607DEE4F16F2}" dt="2023-09-07T11:13:56.860" v="277" actId="20577"/>
        <pc:sldMkLst>
          <pc:docMk/>
          <pc:sldMk cId="1953045928" sldId="280"/>
        </pc:sldMkLst>
        <pc:spChg chg="del">
          <ac:chgData name="Hares, Miriam [mhares]" userId="166e42af-e391-4b3a-8429-d0d3ab1076af" providerId="ADAL" clId="{A237EA95-C6D9-44C1-97A9-607DEE4F16F2}" dt="2023-08-10T10:40:19.126" v="1" actId="478"/>
          <ac:spMkLst>
            <pc:docMk/>
            <pc:sldMk cId="1953045928" sldId="280"/>
            <ac:spMk id="2" creationId="{42847BB1-F68E-4FB4-9D89-9DD8821EA0D2}"/>
          </ac:spMkLst>
        </pc:spChg>
        <pc:spChg chg="del">
          <ac:chgData name="Hares, Miriam [mhares]" userId="166e42af-e391-4b3a-8429-d0d3ab1076af" providerId="ADAL" clId="{A237EA95-C6D9-44C1-97A9-607DEE4F16F2}" dt="2023-08-10T10:40:20.831" v="2" actId="478"/>
          <ac:spMkLst>
            <pc:docMk/>
            <pc:sldMk cId="1953045928" sldId="280"/>
            <ac:spMk id="3" creationId="{C77AA066-8CC5-41DF-B43C-ED7B1A153270}"/>
          </ac:spMkLst>
        </pc:spChg>
        <pc:spChg chg="add mod">
          <ac:chgData name="Hares, Miriam [mhares]" userId="166e42af-e391-4b3a-8429-d0d3ab1076af" providerId="ADAL" clId="{A237EA95-C6D9-44C1-97A9-607DEE4F16F2}" dt="2023-09-07T11:13:56.860" v="277" actId="20577"/>
          <ac:spMkLst>
            <pc:docMk/>
            <pc:sldMk cId="1953045928" sldId="280"/>
            <ac:spMk id="6" creationId="{3B88172A-85B6-453C-8D12-167DE69EF5D9}"/>
          </ac:spMkLst>
        </pc:spChg>
        <pc:picChg chg="add del mod">
          <ac:chgData name="Hares, Miriam [mhares]" userId="166e42af-e391-4b3a-8429-d0d3ab1076af" providerId="ADAL" clId="{A237EA95-C6D9-44C1-97A9-607DEE4F16F2}" dt="2023-08-10T10:44:16.961" v="10" actId="478"/>
          <ac:picMkLst>
            <pc:docMk/>
            <pc:sldMk cId="1953045928" sldId="280"/>
            <ac:picMk id="4" creationId="{E8B84A68-94D3-4550-A287-3F2ADE32494D}"/>
          </ac:picMkLst>
        </pc:picChg>
        <pc:picChg chg="add mod">
          <ac:chgData name="Hares, Miriam [mhares]" userId="166e42af-e391-4b3a-8429-d0d3ab1076af" providerId="ADAL" clId="{A237EA95-C6D9-44C1-97A9-607DEE4F16F2}" dt="2023-08-10T10:44:44.374" v="17" actId="14100"/>
          <ac:picMkLst>
            <pc:docMk/>
            <pc:sldMk cId="1953045928" sldId="280"/>
            <ac:picMk id="5" creationId="{9F35D7DB-1D6F-4D6D-AE0E-709E0BC58577}"/>
          </ac:picMkLst>
        </pc:picChg>
      </pc:sldChg>
    </pc:docChg>
  </pc:docChgLst>
  <pc:docChgLst>
    <pc:chgData name="Hares, Miriam [mhares]" userId="166e42af-e391-4b3a-8429-d0d3ab1076af" providerId="ADAL" clId="{3093E9C9-34D1-4112-AABD-A0CF3C42E6E4}"/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79351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55569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004862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84664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83027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07559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66058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51432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199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74926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87984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0553E9-EC3C-419B-A8CA-32C949EBAF28}" type="datetimeFigureOut">
              <a:rPr lang="en-GB" smtClean="0"/>
              <a:t>07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65358-B5DB-4704-8D3F-2A92564A2AE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03289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F35D7DB-1D6F-4D6D-AE0E-709E0BC585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-8965"/>
            <a:ext cx="6858001" cy="509753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B88172A-85B6-453C-8D12-167DE69EF5D9}"/>
              </a:ext>
            </a:extLst>
          </p:cNvPr>
          <p:cNvSpPr txBox="1"/>
          <p:nvPr/>
        </p:nvSpPr>
        <p:spPr>
          <a:xfrm>
            <a:off x="-1" y="5088567"/>
            <a:ext cx="682458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1. </a:t>
            </a:r>
            <a:r>
              <a:rPr lang="en-GB" sz="1200" dirty="0"/>
              <a:t>Experimental study design. One faecal swab sample was collected from each calf enrolled during week 1 of life from three farms (n=346). Calves were observed for signs of diarrhoeal disease amongst other health monitoring checks. Calves that exhibited diarrhoea had a swab taken at the point of scour and a LFT to determine the cause of diarrhoea. Healthy control calves (n = 33) and calves that tested positive for </a:t>
            </a:r>
            <a:r>
              <a:rPr lang="en-GB" sz="1200" i="1" dirty="0"/>
              <a:t>C. parvum </a:t>
            </a:r>
            <a:r>
              <a:rPr lang="en-GB" sz="1200" dirty="0"/>
              <a:t>(n = 32) were selected matching for age, sex, breed, and prior treatment where possible. Week 1 faecal swab samples from the selected control and </a:t>
            </a:r>
            <a:r>
              <a:rPr lang="en-GB" sz="1200" i="1" dirty="0"/>
              <a:t>Cryptosporidium</a:t>
            </a:r>
            <a:r>
              <a:rPr lang="en-GB" sz="1200" dirty="0"/>
              <a:t>-positive calves were extracted and DNA that did not meet CGR QC requirements was excluded from the study (n = 5). The final 60 DNA samples underwent shotgun metagenomic sequencing, processing, and analysis.</a:t>
            </a:r>
            <a:br>
              <a:rPr lang="en-GB" sz="1200" b="1" dirty="0">
                <a:solidFill>
                  <a:srgbClr val="FF0000"/>
                </a:solidFill>
              </a:rPr>
            </a:br>
            <a:endParaRPr lang="en-GB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5304592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A2AAD6C5-35CF-48CC-BE0B-5EFCEFB0B9D3}"/>
              </a:ext>
            </a:extLst>
          </p:cNvPr>
          <p:cNvSpPr txBox="1"/>
          <p:nvPr/>
        </p:nvSpPr>
        <p:spPr>
          <a:xfrm>
            <a:off x="52196" y="6537030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10. </a:t>
            </a:r>
            <a:r>
              <a:rPr lang="en-GB" sz="1200" dirty="0"/>
              <a:t>Flowchart of the purine nucleotide salvage pathway and inosine-5-monophosphate degradation pathway. Based on the MetaCyc database pathway [93]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62378CD-6A79-47CD-9A20-D38A08AA11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116" y="123482"/>
            <a:ext cx="6553768" cy="64135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8101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35F7B94-BC90-4559-9BE3-81F9AE49E0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0107861"/>
              </p:ext>
            </p:extLst>
          </p:nvPr>
        </p:nvGraphicFramePr>
        <p:xfrm>
          <a:off x="34694" y="309025"/>
          <a:ext cx="6788614" cy="6328373"/>
        </p:xfrm>
        <a:graphic>
          <a:graphicData uri="http://schemas.openxmlformats.org/drawingml/2006/table">
            <a:tbl>
              <a:tblPr firstRow="1" firstCol="1" bandRow="1"/>
              <a:tblGrid>
                <a:gridCol w="652782">
                  <a:extLst>
                    <a:ext uri="{9D8B030D-6E8A-4147-A177-3AD203B41FA5}">
                      <a16:colId xmlns:a16="http://schemas.microsoft.com/office/drawing/2014/main" val="3551361595"/>
                    </a:ext>
                  </a:extLst>
                </a:gridCol>
                <a:gridCol w="978787">
                  <a:extLst>
                    <a:ext uri="{9D8B030D-6E8A-4147-A177-3AD203B41FA5}">
                      <a16:colId xmlns:a16="http://schemas.microsoft.com/office/drawing/2014/main" val="886450638"/>
                    </a:ext>
                  </a:extLst>
                </a:gridCol>
                <a:gridCol w="978021">
                  <a:extLst>
                    <a:ext uri="{9D8B030D-6E8A-4147-A177-3AD203B41FA5}">
                      <a16:colId xmlns:a16="http://schemas.microsoft.com/office/drawing/2014/main" val="3032218511"/>
                    </a:ext>
                  </a:extLst>
                </a:gridCol>
                <a:gridCol w="761705">
                  <a:extLst>
                    <a:ext uri="{9D8B030D-6E8A-4147-A177-3AD203B41FA5}">
                      <a16:colId xmlns:a16="http://schemas.microsoft.com/office/drawing/2014/main" val="3167739769"/>
                    </a:ext>
                  </a:extLst>
                </a:gridCol>
                <a:gridCol w="699573">
                  <a:extLst>
                    <a:ext uri="{9D8B030D-6E8A-4147-A177-3AD203B41FA5}">
                      <a16:colId xmlns:a16="http://schemas.microsoft.com/office/drawing/2014/main" val="1241798914"/>
                    </a:ext>
                  </a:extLst>
                </a:gridCol>
                <a:gridCol w="978021">
                  <a:extLst>
                    <a:ext uri="{9D8B030D-6E8A-4147-A177-3AD203B41FA5}">
                      <a16:colId xmlns:a16="http://schemas.microsoft.com/office/drawing/2014/main" val="3911992538"/>
                    </a:ext>
                  </a:extLst>
                </a:gridCol>
                <a:gridCol w="978787">
                  <a:extLst>
                    <a:ext uri="{9D8B030D-6E8A-4147-A177-3AD203B41FA5}">
                      <a16:colId xmlns:a16="http://schemas.microsoft.com/office/drawing/2014/main" val="2453686574"/>
                    </a:ext>
                  </a:extLst>
                </a:gridCol>
                <a:gridCol w="760938">
                  <a:extLst>
                    <a:ext uri="{9D8B030D-6E8A-4147-A177-3AD203B41FA5}">
                      <a16:colId xmlns:a16="http://schemas.microsoft.com/office/drawing/2014/main" val="2815468141"/>
                    </a:ext>
                  </a:extLst>
                </a:gridCol>
              </a:tblGrid>
              <a:tr h="66615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ntrol Sample ID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w Read Pair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ost Removed Read Pair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ercent Reads Retaine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i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ryptospo</a:t>
                      </a:r>
                      <a:r>
                        <a:rPr lang="en-GB" sz="1100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</a:t>
                      </a:r>
                      <a:r>
                        <a:rPr lang="en-GB" sz="1100" i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idium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Positive Sample ID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w Read Pairs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ost Removed Read Pair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ercent Reads Retaine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5044203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8,061,87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6,171,90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.1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5,090,57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9,935,2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9.9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4142666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1,167,54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,948,55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.7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41,911,6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,596,68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6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719602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3,028,32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5,872,99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.7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9,754,88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6,332,60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4.2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9782577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8,212,24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6,545,15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1.4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0,348,13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6,720,04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5.8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713795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5,524,05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,489,0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.9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1,365,47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1,043,86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2.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4360959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7,250,6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,997,40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.8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9,190,36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7,754,45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9.4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0754922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7,926,77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9,344,42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2.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4,960,38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7,131,33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.0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059365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5,309,4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4,025,18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1.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4,759,5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2,323,59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.4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2866120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2,833,83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4,322,04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.5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83,362,06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6,892,8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.5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0743719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4,297,77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0,220,52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.1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14,080,2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7,510,15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0.3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563611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5,681,95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9,179,34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2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6,589,39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1,185,19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6.3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8232451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56,316,14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44,308,39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5.3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6,218,1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2,341,5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7.8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5811236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13,438,58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49,059,22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.2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3,189,3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7,191,17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.6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3088091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67,729,45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4,782,65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2.7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50,156,1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,149,50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.2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6397466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6,212,77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1,097,1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.4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7,173,77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9,147,3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.7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0560984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1,899,88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5,808,0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7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2,963,19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5,612,50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3.0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0252198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5,578,72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8,158,44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0.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9,207,08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0,532,93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5.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384823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5,165,05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21,086,9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4.0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0,583,53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0,948,26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3.1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6946408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1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51,236,5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1,463,65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.5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4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81,267,06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6,904,46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.9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6015570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0,736,6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4,446,13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.8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21,248,25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7,174,6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.9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3592725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8,013,59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,576,50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.9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7,158,22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5,155,48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3.0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5311013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9,331,87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2,680,4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2.4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0,881,6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6,044,23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8.3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1887548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4,269,2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6,820,03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8.6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7,498,17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8,393,76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7.8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5106707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9,937,87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0,997,8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0.4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6,628,6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,121,50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.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69384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29,403,8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,010,52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.8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6,935,04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2,352,81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7.8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515157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7,558,75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,176,36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1.0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84,175,8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1,401,82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9.2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565908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5,493,28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0,523,94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.7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3,377,58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5,901,27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5.9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4023889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0,442,89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8,892,15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1.7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60,200,39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4,058,94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.8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2190088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2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9,952,13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5,442,1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8.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5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9,272,19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4,604,69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.0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1594303"/>
                  </a:ext>
                </a:extLst>
              </a:tr>
              <a:tr h="1872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3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1,665,47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7,073,22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0.6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lf_6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9,634,51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4,802,32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4.5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0278" marR="402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544788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D190061-81A3-4091-BA7D-A8270420DD28}"/>
              </a:ext>
            </a:extLst>
          </p:cNvPr>
          <p:cNvSpPr txBox="1"/>
          <p:nvPr/>
        </p:nvSpPr>
        <p:spPr>
          <a:xfrm>
            <a:off x="-1282" y="0"/>
            <a:ext cx="68245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Table S1. </a:t>
            </a:r>
            <a:r>
              <a:rPr lang="en-GB" sz="1200" dirty="0"/>
              <a:t>Percentage of reads retained after removal of host reads.</a:t>
            </a:r>
            <a:br>
              <a:rPr lang="en-GB" sz="1200" b="1" dirty="0">
                <a:solidFill>
                  <a:srgbClr val="FF0000"/>
                </a:solidFill>
              </a:rPr>
            </a:br>
            <a:endParaRPr lang="en-GB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59171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125619D0-D738-4907-827A-8CFC8CEAD004}"/>
              </a:ext>
            </a:extLst>
          </p:cNvPr>
          <p:cNvGrpSpPr/>
          <p:nvPr/>
        </p:nvGrpSpPr>
        <p:grpSpPr>
          <a:xfrm>
            <a:off x="0" y="18834"/>
            <a:ext cx="6858000" cy="4186829"/>
            <a:chOff x="0" y="18834"/>
            <a:chExt cx="6858000" cy="418682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5B07925-57BB-461D-8107-752A95844E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598" t="80799" r="65529" b="7132"/>
            <a:stretch/>
          </p:blipFill>
          <p:spPr>
            <a:xfrm>
              <a:off x="1959430" y="3291261"/>
              <a:ext cx="402772" cy="56061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49D8782-89FB-4526-8D1B-A5A3F92098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250" b="23788"/>
            <a:stretch/>
          </p:blipFill>
          <p:spPr>
            <a:xfrm>
              <a:off x="0" y="1910445"/>
              <a:ext cx="6858000" cy="139170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1F49F8D-DC61-4373-940C-52F0FB0843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7" t="36642" b="53280"/>
            <a:stretch/>
          </p:blipFill>
          <p:spPr>
            <a:xfrm>
              <a:off x="277587" y="1403425"/>
              <a:ext cx="6580413" cy="46808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F3B1565-E9E8-4C4C-BE17-A7F68BF356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6" t="82811" r="71509" b="6760"/>
            <a:stretch/>
          </p:blipFill>
          <p:spPr>
            <a:xfrm>
              <a:off x="283030" y="3302147"/>
              <a:ext cx="1676400" cy="48441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C95D253-4A4D-4C85-A625-06E31EC6CB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0038"/>
            <a:stretch/>
          </p:blipFill>
          <p:spPr>
            <a:xfrm>
              <a:off x="0" y="18834"/>
              <a:ext cx="6858000" cy="139170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971B53C-0BFF-4B8B-88D4-D2D5E6865A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122" b="-504"/>
            <a:stretch/>
          </p:blipFill>
          <p:spPr>
            <a:xfrm>
              <a:off x="0" y="3862763"/>
              <a:ext cx="6858000" cy="342900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9986C42B-BDEF-45F3-BAFE-37A0408BFDCC}"/>
              </a:ext>
            </a:extLst>
          </p:cNvPr>
          <p:cNvSpPr txBox="1"/>
          <p:nvPr/>
        </p:nvSpPr>
        <p:spPr>
          <a:xfrm>
            <a:off x="-1818" y="4283603"/>
            <a:ext cx="68245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2. </a:t>
            </a:r>
            <a:r>
              <a:rPr lang="en-GB" sz="1200" dirty="0"/>
              <a:t>The total number of reads obtained for each sample.</a:t>
            </a:r>
            <a:br>
              <a:rPr lang="en-GB" sz="1200" dirty="0">
                <a:solidFill>
                  <a:srgbClr val="FF0000"/>
                </a:solidFill>
              </a:rPr>
            </a:br>
            <a:endParaRPr lang="en-GB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08152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55D5C437-85B6-4AF2-82B2-2599A318F806}"/>
              </a:ext>
            </a:extLst>
          </p:cNvPr>
          <p:cNvGrpSpPr/>
          <p:nvPr/>
        </p:nvGrpSpPr>
        <p:grpSpPr>
          <a:xfrm>
            <a:off x="0" y="160622"/>
            <a:ext cx="6858000" cy="8471745"/>
            <a:chOff x="0" y="160622"/>
            <a:chExt cx="6858000" cy="847174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E7B772A-7983-44D9-A00E-AB547174B7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4242"/>
            <a:stretch/>
          </p:blipFill>
          <p:spPr>
            <a:xfrm>
              <a:off x="0" y="160622"/>
              <a:ext cx="6858000" cy="151033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9E5B70B-9818-4AC3-A94A-86E76EBA08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220" b="60449"/>
            <a:stretch/>
          </p:blipFill>
          <p:spPr>
            <a:xfrm>
              <a:off x="0" y="1692728"/>
              <a:ext cx="6858000" cy="1948543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8D6A8A0-B2EB-4A93-ABF9-E8EA22B5E5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960" b="36540"/>
            <a:stretch/>
          </p:blipFill>
          <p:spPr>
            <a:xfrm>
              <a:off x="0" y="3663041"/>
              <a:ext cx="6858000" cy="196487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5082552-C726-4B3C-9DD1-52C6C2A570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810" b="12690"/>
            <a:stretch/>
          </p:blipFill>
          <p:spPr>
            <a:xfrm>
              <a:off x="0" y="5649683"/>
              <a:ext cx="6858000" cy="1964871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7FB5F5C-6F4C-4257-B6CD-C25EDF5D6E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0603" r="23810" b="-995"/>
            <a:stretch/>
          </p:blipFill>
          <p:spPr>
            <a:xfrm>
              <a:off x="0" y="7636324"/>
              <a:ext cx="5225143" cy="996043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CC04A9E9-37A3-4E18-9420-A67C1A2E82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348" t="87309" r="5715" b="4968"/>
            <a:stretch/>
          </p:blipFill>
          <p:spPr>
            <a:xfrm>
              <a:off x="5236024" y="7630885"/>
              <a:ext cx="1230085" cy="740228"/>
            </a:xfrm>
            <a:prstGeom prst="rect">
              <a:avLst/>
            </a:prstGeom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AC4B85E7-70FF-4A20-B692-777613C2B159}"/>
              </a:ext>
            </a:extLst>
          </p:cNvPr>
          <p:cNvSpPr txBox="1"/>
          <p:nvPr/>
        </p:nvSpPr>
        <p:spPr>
          <a:xfrm>
            <a:off x="-1818" y="8545382"/>
            <a:ext cx="68245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3. </a:t>
            </a:r>
            <a:r>
              <a:rPr lang="en-GB" sz="1200" dirty="0"/>
              <a:t>The distribution of trimmed read lengths for the forward (R1), reverse (R2) and singlet (R0) reads.</a:t>
            </a:r>
          </a:p>
        </p:txBody>
      </p:sp>
    </p:spTree>
    <p:extLst>
      <p:ext uri="{BB962C8B-B14F-4D97-AF65-F5344CB8AC3E}">
        <p14:creationId xmlns:p14="http://schemas.microsoft.com/office/powerpoint/2010/main" val="18520454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64CC8A49-5B8F-4564-AEDD-D8384F0CA666}"/>
              </a:ext>
            </a:extLst>
          </p:cNvPr>
          <p:cNvSpPr txBox="1"/>
          <p:nvPr/>
        </p:nvSpPr>
        <p:spPr>
          <a:xfrm>
            <a:off x="0" y="9629001"/>
            <a:ext cx="682458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4</a:t>
            </a:r>
            <a:r>
              <a:rPr lang="en-GB" sz="1200" dirty="0"/>
              <a:t>. Alpha and beta diversity of disease status and sample collection day group interaction. A) Species richness in control Day 1–3 (n = 7) and </a:t>
            </a:r>
            <a:r>
              <a:rPr lang="en-GB" sz="1200" i="1" dirty="0"/>
              <a:t>Cryptosporidium</a:t>
            </a:r>
            <a:r>
              <a:rPr lang="en-GB" sz="1200" dirty="0"/>
              <a:t>-positive Day 1–3 (n = 13) groups; T-test, </a:t>
            </a:r>
            <a:r>
              <a:rPr lang="en-GB" sz="1200" i="1" dirty="0"/>
              <a:t>p</a:t>
            </a:r>
            <a:r>
              <a:rPr lang="en-GB" sz="1200" dirty="0"/>
              <a:t> = 0.21, and control Day 4–7 (n = 23) and </a:t>
            </a:r>
            <a:r>
              <a:rPr lang="en-GB" sz="1200" i="1" dirty="0"/>
              <a:t>Cryptosporidium</a:t>
            </a:r>
            <a:r>
              <a:rPr lang="en-GB" sz="1200" dirty="0"/>
              <a:t>-positive Day 4–7 (n = 17) groups; T-test, </a:t>
            </a:r>
            <a:r>
              <a:rPr lang="en-GB" sz="1200" i="1" dirty="0"/>
              <a:t>p</a:t>
            </a:r>
            <a:r>
              <a:rPr lang="en-GB" sz="1200" dirty="0"/>
              <a:t> = 0.85. B) Shannon index of control Day 1–3 (n = 7) and </a:t>
            </a:r>
            <a:r>
              <a:rPr lang="en-GB" sz="1200" i="1" dirty="0"/>
              <a:t>Cryptosporidium</a:t>
            </a:r>
            <a:r>
              <a:rPr lang="en-GB" sz="1200" dirty="0"/>
              <a:t>-positive Day 1–3 (n = 13) groups; Wilcoxon, </a:t>
            </a:r>
            <a:r>
              <a:rPr lang="en-GB" sz="1200" i="1" dirty="0"/>
              <a:t>p</a:t>
            </a:r>
            <a:r>
              <a:rPr lang="en-GB" sz="1200" dirty="0"/>
              <a:t> = 0.081, and control Day 4–7 (n = 23) and </a:t>
            </a:r>
            <a:r>
              <a:rPr lang="en-GB" sz="1200" i="1" dirty="0"/>
              <a:t>Cryptosporidium</a:t>
            </a:r>
            <a:r>
              <a:rPr lang="en-GB" sz="1200" dirty="0"/>
              <a:t>-positive Day 4–7 (n = 17) groups; Wilcoxon, </a:t>
            </a:r>
            <a:r>
              <a:rPr lang="en-GB" sz="1200" i="1" dirty="0"/>
              <a:t>p</a:t>
            </a:r>
            <a:r>
              <a:rPr lang="en-GB" sz="1200" dirty="0"/>
              <a:t> = 0.67. C) Bray Curtis PCoA ordination of control Day 1–3 (n = 7) and </a:t>
            </a:r>
            <a:r>
              <a:rPr lang="en-GB" sz="1200" i="1" dirty="0"/>
              <a:t>Cryptosporidium</a:t>
            </a:r>
            <a:r>
              <a:rPr lang="en-GB" sz="1200" dirty="0"/>
              <a:t>-positive Day 1–3 (n = 13) groups; PERMANOVA, </a:t>
            </a:r>
            <a:r>
              <a:rPr lang="en-GB" sz="1200" i="1" dirty="0"/>
              <a:t>p</a:t>
            </a:r>
            <a:r>
              <a:rPr lang="en-GB" sz="1200" dirty="0"/>
              <a:t> = 0.45,  and control Day 4–7 (n = 23) and </a:t>
            </a:r>
            <a:r>
              <a:rPr lang="en-GB" sz="1200" i="1" dirty="0"/>
              <a:t>Cryptosporidium</a:t>
            </a:r>
            <a:r>
              <a:rPr lang="en-GB" sz="1200" dirty="0"/>
              <a:t>-positive Day 4–7 (n = 17) groups; PERMANOVA, </a:t>
            </a:r>
            <a:r>
              <a:rPr lang="en-GB" sz="1200" i="1" dirty="0"/>
              <a:t>p</a:t>
            </a:r>
            <a:r>
              <a:rPr lang="en-GB" sz="1200" dirty="0"/>
              <a:t> = 0.82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1D3D9F5-1C90-4C97-BF8C-16F64098A6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238750" cy="952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75250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872F46-72BE-4CC3-BED4-CB279D6F508B}"/>
              </a:ext>
            </a:extLst>
          </p:cNvPr>
          <p:cNvSpPr txBox="1"/>
          <p:nvPr/>
        </p:nvSpPr>
        <p:spPr>
          <a:xfrm>
            <a:off x="0" y="9121725"/>
            <a:ext cx="68245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5. </a:t>
            </a:r>
            <a:r>
              <a:rPr lang="en-GB" sz="1200" dirty="0"/>
              <a:t>Per sample relative abundance. A) Phyla relative abundance (≥1%) per sample in chronological order of day of sampling. B) Genera relative abundance (≥1%) per sample in chronological order of day of sampling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C1839D3-D3D5-460A-B3F9-1EDE38D83C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06" y="0"/>
            <a:ext cx="6841294" cy="9121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35383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2D7A7B8-48C5-446F-B4D2-DEBAAF0F1B15}"/>
              </a:ext>
            </a:extLst>
          </p:cNvPr>
          <p:cNvSpPr txBox="1"/>
          <p:nvPr/>
        </p:nvSpPr>
        <p:spPr>
          <a:xfrm>
            <a:off x="0" y="3281362"/>
            <a:ext cx="682458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6. </a:t>
            </a:r>
            <a:r>
              <a:rPr lang="en-GB" sz="1200" dirty="0"/>
              <a:t>Significant Taxa. A) Significant TSS normalised Bracken species relative abundance of the control and </a:t>
            </a:r>
            <a:r>
              <a:rPr lang="en-GB" sz="1200" i="1" dirty="0"/>
              <a:t>Cryptosporidium</a:t>
            </a:r>
            <a:r>
              <a:rPr lang="en-GB" sz="1200" dirty="0"/>
              <a:t>-positive groups shows that </a:t>
            </a:r>
            <a:r>
              <a:rPr lang="en-GB" sz="1200" i="1" dirty="0"/>
              <a:t>Veillonella rodentium </a:t>
            </a:r>
            <a:r>
              <a:rPr lang="en-GB" sz="1200" dirty="0"/>
              <a:t>relative abundance is significantly lower in the control group (n = 1) versus the </a:t>
            </a:r>
            <a:r>
              <a:rPr lang="en-GB" sz="1200" i="1" dirty="0"/>
              <a:t>Cryptosporidium</a:t>
            </a:r>
            <a:r>
              <a:rPr lang="en-GB" sz="1200" dirty="0"/>
              <a:t>-positive group (n = 8); </a:t>
            </a:r>
            <a:r>
              <a:rPr lang="en-GB" sz="1200" i="1" dirty="0"/>
              <a:t>q</a:t>
            </a:r>
            <a:r>
              <a:rPr lang="en-GB" sz="1200" dirty="0"/>
              <a:t> = 0.21. B) Significant TSS normalised MetaPhlAn2 species relative abundance of the control and </a:t>
            </a:r>
            <a:r>
              <a:rPr lang="en-GB" sz="1200" i="1" dirty="0"/>
              <a:t>Cryptosporidium</a:t>
            </a:r>
            <a:r>
              <a:rPr lang="en-GB" sz="1200" dirty="0"/>
              <a:t>-positive groups shows that </a:t>
            </a:r>
            <a:r>
              <a:rPr lang="en-GB" sz="1200" i="1" dirty="0"/>
              <a:t>Veillonella</a:t>
            </a:r>
            <a:r>
              <a:rPr lang="en-GB" sz="1200" dirty="0"/>
              <a:t> sp. CAG 933 relative abundance is significantly lower in the control group (n = 13) versus the </a:t>
            </a:r>
            <a:r>
              <a:rPr lang="en-GB" sz="1200" i="1" dirty="0"/>
              <a:t>Cryptosporidium</a:t>
            </a:r>
            <a:r>
              <a:rPr lang="en-GB" sz="1200" dirty="0"/>
              <a:t>-positive group (n = 10); </a:t>
            </a:r>
            <a:r>
              <a:rPr lang="en-GB" sz="1200" i="1" dirty="0"/>
              <a:t>q</a:t>
            </a:r>
            <a:r>
              <a:rPr lang="en-GB" sz="1200" dirty="0"/>
              <a:t> = 0.16.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A3AC8DD-144A-4922-8797-B44F7C4CD7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6102191"/>
              </p:ext>
            </p:extLst>
          </p:nvPr>
        </p:nvGraphicFramePr>
        <p:xfrm>
          <a:off x="0" y="0"/>
          <a:ext cx="6858000" cy="3281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9211590" imgH="4403770" progId="Prism9.Document">
                  <p:embed/>
                </p:oleObj>
              </mc:Choice>
              <mc:Fallback>
                <p:oleObj name="Prism 9" r:id="rId3" imgW="9211590" imgH="4403770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A3AC8DD-144A-4922-8797-B44F7C4CD7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6858000" cy="3281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965782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93F1E42-4417-492A-85E2-69E79DBD2BF8}"/>
              </a:ext>
            </a:extLst>
          </p:cNvPr>
          <p:cNvSpPr txBox="1"/>
          <p:nvPr/>
        </p:nvSpPr>
        <p:spPr>
          <a:xfrm>
            <a:off x="0" y="4543455"/>
            <a:ext cx="68245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7. </a:t>
            </a:r>
            <a:r>
              <a:rPr lang="en-GB" sz="1200" dirty="0"/>
              <a:t>MetaCyc Pathway ID and Q-values of significant pathway relative abundances between the control and the </a:t>
            </a:r>
            <a:r>
              <a:rPr lang="en-GB" sz="1200" i="1" dirty="0"/>
              <a:t>Cryptosporidium</a:t>
            </a:r>
            <a:r>
              <a:rPr lang="en-GB" sz="1200" dirty="0"/>
              <a:t>-positive groups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232FD35-F68B-49F9-A35A-97F4DF768F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821" y="105182"/>
            <a:ext cx="5724640" cy="44382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67386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1F6AF35-9227-487B-965D-D36D983B2A4B}"/>
              </a:ext>
            </a:extLst>
          </p:cNvPr>
          <p:cNvSpPr txBox="1"/>
          <p:nvPr/>
        </p:nvSpPr>
        <p:spPr>
          <a:xfrm>
            <a:off x="0" y="7886700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8. </a:t>
            </a:r>
            <a:r>
              <a:rPr lang="en-GB" sz="1200" dirty="0"/>
              <a:t>Flowchart of the MEP pathway and downstream processes. Based on the MetaCyc database pathway [93].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90C2EC06-684C-4F2D-9F31-D7669B3955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344" y="0"/>
            <a:ext cx="6651312" cy="7901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12832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2EB9BAC0-AD9C-4737-BE6A-A67FEA2DA460}"/>
              </a:ext>
            </a:extLst>
          </p:cNvPr>
          <p:cNvSpPr txBox="1"/>
          <p:nvPr/>
        </p:nvSpPr>
        <p:spPr>
          <a:xfrm>
            <a:off x="52196" y="5650570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9. </a:t>
            </a:r>
            <a:r>
              <a:rPr lang="en-GB" sz="1200" dirty="0"/>
              <a:t>Flowchart of the superpathway of haem biosynthesis from glycine. Based on the MetaCyc database pathway [93].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EB8D1D5A-5B19-4283-B804-BB4F746795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467" y="72247"/>
            <a:ext cx="6383065" cy="55783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9154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69AB6E3D5ECFC48BE3F7A8B927A5CEF" ma:contentTypeVersion="15" ma:contentTypeDescription="Create a new document." ma:contentTypeScope="" ma:versionID="032e7ebce2fb11b7e445e04b94959a94">
  <xsd:schema xmlns:xsd="http://www.w3.org/2001/XMLSchema" xmlns:xs="http://www.w3.org/2001/XMLSchema" xmlns:p="http://schemas.microsoft.com/office/2006/metadata/properties" xmlns:ns3="155cf25c-ec18-4360-962a-9a67d8b45796" xmlns:ns4="5574eff3-9871-44e3-ac19-f1cce5bf97ab" targetNamespace="http://schemas.microsoft.com/office/2006/metadata/properties" ma:root="true" ma:fieldsID="b0844b12f2fbd793b18c694f71ad7ff2" ns3:_="" ns4:_="">
    <xsd:import namespace="155cf25c-ec18-4360-962a-9a67d8b45796"/>
    <xsd:import namespace="5574eff3-9871-44e3-ac19-f1cce5bf97a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55cf25c-ec18-4360-962a-9a67d8b4579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574eff3-9871-44e3-ac19-f1cce5bf97ab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55cf25c-ec18-4360-962a-9a67d8b45796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EAE2ADD-30FA-4294-A7C0-8E169C74100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55cf25c-ec18-4360-962a-9a67d8b45796"/>
    <ds:schemaRef ds:uri="5574eff3-9871-44e3-ac19-f1cce5bf97a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CD5C966-E76D-4072-9E57-C2A31EFC3A5B}">
  <ds:schemaRefs>
    <ds:schemaRef ds:uri="http://schemas.openxmlformats.org/package/2006/metadata/core-properties"/>
    <ds:schemaRef ds:uri="http://schemas.microsoft.com/office/2006/metadata/properties"/>
    <ds:schemaRef ds:uri="155cf25c-ec18-4360-962a-9a67d8b45796"/>
    <ds:schemaRef ds:uri="http://schemas.microsoft.com/office/2006/documentManagement/types"/>
    <ds:schemaRef ds:uri="http://purl.org/dc/dcmitype/"/>
    <ds:schemaRef ds:uri="http://purl.org/dc/elements/1.1/"/>
    <ds:schemaRef ds:uri="http://purl.org/dc/terms/"/>
    <ds:schemaRef ds:uri="http://www.w3.org/XML/1998/namespace"/>
    <ds:schemaRef ds:uri="http://schemas.microsoft.com/office/infopath/2007/PartnerControls"/>
    <ds:schemaRef ds:uri="5574eff3-9871-44e3-ac19-f1cce5bf97ab"/>
  </ds:schemaRefs>
</ds:datastoreItem>
</file>

<file path=customXml/itemProps3.xml><?xml version="1.0" encoding="utf-8"?>
<ds:datastoreItem xmlns:ds="http://schemas.openxmlformats.org/officeDocument/2006/customXml" ds:itemID="{81779513-CBB3-4B1B-9E26-CCD6E12B1D7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46</TotalTime>
  <Words>1054</Words>
  <Application>Microsoft Office PowerPoint</Application>
  <PresentationFormat>A4 Paper (210x297 mm)</PresentationFormat>
  <Paragraphs>259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iam Hares</dc:creator>
  <cp:lastModifiedBy>Hares, Miriam [mhares]</cp:lastModifiedBy>
  <cp:revision>144</cp:revision>
  <dcterms:created xsi:type="dcterms:W3CDTF">2022-02-14T14:18:19Z</dcterms:created>
  <dcterms:modified xsi:type="dcterms:W3CDTF">2023-09-07T16:44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69AB6E3D5ECFC48BE3F7A8B927A5CEF</vt:lpwstr>
  </property>
</Properties>
</file>